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" userDrawn="1">
          <p15:clr>
            <a:srgbClr val="A4A3A4"/>
          </p15:clr>
        </p15:guide>
        <p15:guide id="2" pos="1323" userDrawn="1">
          <p15:clr>
            <a:srgbClr val="A4A3A4"/>
          </p15:clr>
        </p15:guide>
        <p15:guide id="3" orient="horz" pos="777" userDrawn="1">
          <p15:clr>
            <a:srgbClr val="A4A3A4"/>
          </p15:clr>
        </p15:guide>
        <p15:guide id="4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Joong Lee" initials="Lee" lastIdx="4" clrIdx="0">
    <p:extLst>
      <p:ext uri="{19B8F6BF-5375-455C-9EA6-DF929625EA0E}">
        <p15:presenceInfo xmlns:p15="http://schemas.microsoft.com/office/powerpoint/2012/main" userId="HeeJoong Le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141" autoAdjust="0"/>
  </p:normalViewPr>
  <p:slideViewPr>
    <p:cSldViewPr snapToGrid="0">
      <p:cViewPr varScale="1">
        <p:scale>
          <a:sx n="77" d="100"/>
          <a:sy n="77" d="100"/>
        </p:scale>
        <p:origin x="806" y="72"/>
      </p:cViewPr>
      <p:guideLst>
        <p:guide orient="horz" pos="595"/>
        <p:guide pos="1323"/>
        <p:guide orient="horz" pos="77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B55E22-3B9A-4D2C-A739-37567EA8C95B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9D4F8-23FB-4C07-A8F0-B30230CBB7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8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29D4F8-23FB-4C07-A8F0-B30230CBB7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957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55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29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99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7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72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8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5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80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63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53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1818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313986"/>
            <a:ext cx="12191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imes between HRT commencement and the diagnosis of ovarian cancer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9537" y="1233488"/>
            <a:ext cx="8332926" cy="5420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117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17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eong Ji</dc:creator>
  <cp:lastModifiedBy>Banghyun Lee</cp:lastModifiedBy>
  <cp:revision>38</cp:revision>
  <dcterms:created xsi:type="dcterms:W3CDTF">2022-01-28T09:16:13Z</dcterms:created>
  <dcterms:modified xsi:type="dcterms:W3CDTF">2023-02-06T09:25:11Z</dcterms:modified>
</cp:coreProperties>
</file>